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10288588" cy="6858000"/>
  <p:notesSz cx="9867900" cy="673576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9867600" cy="6735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1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-360"/>
            <a:ext cx="4275000" cy="374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5590800" y="-360"/>
            <a:ext cx="4275000" cy="374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3024000" y="523440"/>
            <a:ext cx="3817800" cy="25448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ffff00"/>
                </a:solidFill>
                <a:latin typeface="Times New Roman"/>
              </a:rPr>
              <a:t>Click to move the slide</a:t>
            </a:r>
            <a:endParaRPr b="0" lang="en-US" sz="4400" spc="-1" strike="noStrike">
              <a:solidFill>
                <a:srgbClr val="ffff00"/>
              </a:solidFill>
              <a:latin typeface="Times New Roman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1315800" y="3218040"/>
            <a:ext cx="7234200" cy="2993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6361200"/>
            <a:ext cx="4275000" cy="37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5590800" y="6361200"/>
            <a:ext cx="4275000" cy="37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1" lang="en-US" sz="1200" spc="-1" strike="noStrike">
                <a:solidFill>
                  <a:srgbClr val="000000"/>
                </a:solidFill>
                <a:latin typeface="Times New Roman"/>
                <a:ea typeface="中ゴシックＢＢＢ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AF22CD6-3534-4F66-A737-13A25EE8BC85}" type="slidenum">
              <a:rPr b="1" lang="en-US" sz="1200" spc="-1" strike="noStrike">
                <a:solidFill>
                  <a:srgbClr val="000000"/>
                </a:solidFill>
                <a:latin typeface="Times New Roman"/>
                <a:ea typeface="中ゴシックＢＢＢ"/>
              </a:rPr>
              <a:t>&lt;number&gt;</a:t>
            </a:fld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sldImg"/>
          </p:nvPr>
        </p:nvSpPr>
        <p:spPr>
          <a:xfrm>
            <a:off x="3024360" y="523800"/>
            <a:ext cx="3817800" cy="2544840"/>
          </a:xfrm>
          <a:prstGeom prst="rect">
            <a:avLst/>
          </a:prstGeom>
          <a:ln w="0">
            <a:noFill/>
          </a:ln>
        </p:spPr>
      </p:sp>
      <p:sp>
        <p:nvSpPr>
          <p:cNvPr id="64" name="PlaceHolder 2"/>
          <p:cNvSpPr>
            <a:spLocks noGrp="1"/>
          </p:cNvSpPr>
          <p:nvPr>
            <p:ph type="body"/>
          </p:nvPr>
        </p:nvSpPr>
        <p:spPr>
          <a:xfrm>
            <a:off x="1315800" y="3218040"/>
            <a:ext cx="7234200" cy="2993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5" name="スライド番号プレースホルダー 3"/>
          <p:cNvSpPr/>
          <p:nvPr/>
        </p:nvSpPr>
        <p:spPr>
          <a:xfrm>
            <a:off x="5591160" y="6361200"/>
            <a:ext cx="4275000" cy="374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500D200-6530-4847-9003-9E61CC11C7AF}" type="slidenum">
              <a:rPr b="1" lang="en-US" sz="1200" spc="-1" strike="noStrike">
                <a:solidFill>
                  <a:srgbClr val="ffffff"/>
                </a:solidFill>
                <a:latin typeface="Times New Roman"/>
                <a:ea typeface="中ゴシックＢＢＢ"/>
              </a:rPr>
              <a:t>&lt;number&gt;</a:t>
            </a:fld>
            <a:endParaRPr b="1" lang="en-US" sz="1200" spc="-1" strike="noStrike">
              <a:solidFill>
                <a:srgbClr val="ffffff"/>
              </a:solidFill>
              <a:latin typeface="Times New Roman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5F59C0-A913-4059-9EA7-D0A458B1FDA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771120" y="609120"/>
            <a:ext cx="874404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ffff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771120" y="1981080"/>
            <a:ext cx="874404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771120" y="4130640"/>
            <a:ext cx="874404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08AE6A-3957-4CF4-8104-11EBE1E1A19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771120" y="609120"/>
            <a:ext cx="874404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ffff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771120" y="1981080"/>
            <a:ext cx="426708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5252040" y="1981080"/>
            <a:ext cx="426708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771120" y="4130640"/>
            <a:ext cx="426708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5252040" y="4130640"/>
            <a:ext cx="426708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9369DA-41C8-499C-97DC-5D2F287E0B5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771120" y="609120"/>
            <a:ext cx="874404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ffff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771120" y="1981080"/>
            <a:ext cx="28152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727440" y="1981080"/>
            <a:ext cx="28152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683760" y="1981080"/>
            <a:ext cx="28152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771120" y="4130640"/>
            <a:ext cx="28152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727440" y="4130640"/>
            <a:ext cx="28152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683760" y="4130640"/>
            <a:ext cx="28152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3B946E-B826-4D46-B683-7B3BB3DA130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771120" y="609120"/>
            <a:ext cx="874404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ffff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771120" y="1981080"/>
            <a:ext cx="874404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BFF1D7-C3C1-4BC0-B74F-0D913F58D91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771120" y="609120"/>
            <a:ext cx="874404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ffff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771120" y="1981080"/>
            <a:ext cx="874404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F71F00-9A31-4F81-9B06-B4139EC6539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771120" y="609120"/>
            <a:ext cx="874404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ffff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771120" y="1981080"/>
            <a:ext cx="426708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5252040" y="1981080"/>
            <a:ext cx="426708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2B39B4-48C0-40E1-BE0A-D1130B4874D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771120" y="609120"/>
            <a:ext cx="874404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ffff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DD954F-1ADA-4C3A-A601-B703B11A88F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771120" y="609120"/>
            <a:ext cx="874404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FC468D-0216-4A1D-8E9A-DCA79ED7EBE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771120" y="609120"/>
            <a:ext cx="874404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ffff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771120" y="1981080"/>
            <a:ext cx="426708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5252040" y="1981080"/>
            <a:ext cx="426708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771120" y="4130640"/>
            <a:ext cx="426708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C9BB5A-5E4A-40E7-83AA-E2827A51DD0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771120" y="609120"/>
            <a:ext cx="874404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ffff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771120" y="1981080"/>
            <a:ext cx="426708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5252040" y="1981080"/>
            <a:ext cx="426708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5252040" y="4130640"/>
            <a:ext cx="426708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A8FBA2-6C16-4615-A1D2-4AA0B6A5950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771120" y="609120"/>
            <a:ext cx="874404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ffff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771120" y="1981080"/>
            <a:ext cx="426708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5252040" y="1981080"/>
            <a:ext cx="426708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771120" y="4130640"/>
            <a:ext cx="874404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73A591-4ADF-47B7-B426-535DA551CAA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771120" y="609120"/>
            <a:ext cx="874404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ffff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ffff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771120" y="1981080"/>
            <a:ext cx="874404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ffffff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  <a:p>
            <a:pPr lvl="1" marL="735480" indent="-282960">
              <a:spcBef>
                <a:spcPts val="799"/>
              </a:spcBef>
              <a:buClr>
                <a:srgbClr val="ffffff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  <a:p>
            <a:pPr lvl="2" marL="1131480" indent="-226080">
              <a:spcBef>
                <a:spcPts val="799"/>
              </a:spcBef>
              <a:buClr>
                <a:srgbClr val="ffffff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  <a:p>
            <a:pPr lvl="3" marL="1584000" indent="-226080">
              <a:spcBef>
                <a:spcPts val="799"/>
              </a:spcBef>
              <a:buClr>
                <a:srgbClr val="ffffff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ffffff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ffffff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ffffff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771120" y="6248520"/>
            <a:ext cx="214308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514320" y="6248520"/>
            <a:ext cx="32576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7372080" y="6248520"/>
            <a:ext cx="214308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  <a:ea typeface="Osaka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292BC0C-07CD-46A8-91DD-6420F7697EEE}" type="slidenum">
              <a:rPr b="0" lang="en-US" sz="1400" spc="-1" strike="noStrike">
                <a:solidFill>
                  <a:srgbClr val="ffffff"/>
                </a:solidFill>
                <a:latin typeface="Times New Roman"/>
                <a:ea typeface="Osaka"/>
              </a:rPr>
              <a:t>&lt;number&gt;</a:t>
            </a:fld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グループ化 1"/>
          <p:cNvGrpSpPr/>
          <p:nvPr/>
        </p:nvGrpSpPr>
        <p:grpSpPr>
          <a:xfrm>
            <a:off x="-30240" y="216000"/>
            <a:ext cx="10329840" cy="5914800"/>
            <a:chOff x="-30240" y="216000"/>
            <a:chExt cx="10329840" cy="5914800"/>
          </a:xfrm>
        </p:grpSpPr>
        <p:sp>
          <p:nvSpPr>
            <p:cNvPr id="49" name="Text Box 25"/>
            <p:cNvSpPr/>
            <p:nvPr/>
          </p:nvSpPr>
          <p:spPr>
            <a:xfrm>
              <a:off x="47520" y="2158920"/>
              <a:ext cx="4191120" cy="3751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No. pts (</a:t>
              </a:r>
              <a:r>
                <a:rPr b="0" lang="ja-JP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％</a:t>
              </a: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)</a:t>
              </a:r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Complications:</a:t>
              </a:r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　</a:t>
              </a: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Ileus</a:t>
              </a:r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  </a:t>
              </a: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Pyelonephritis</a:t>
              </a:r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  </a:t>
              </a: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Wound infection</a:t>
              </a:r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  </a:t>
              </a: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Epidydimitis</a:t>
              </a:r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  </a:t>
              </a: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Dysraphia</a:t>
              </a:r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  </a:t>
              </a: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Cholecystitis</a:t>
              </a:r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  </a:t>
              </a: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MRSA colitis</a:t>
              </a:r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  </a:t>
              </a: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Melena</a:t>
              </a:r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50" name="Text Box 26"/>
            <p:cNvSpPr/>
            <p:nvPr/>
          </p:nvSpPr>
          <p:spPr>
            <a:xfrm>
              <a:off x="4114800" y="2165400"/>
              <a:ext cx="1558800" cy="3751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19 (37.3</a:t>
              </a:r>
              <a:r>
                <a:rPr b="0" lang="ja-JP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）</a:t>
              </a:r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4 (7.8)</a:t>
              </a:r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4 (7.8)</a:t>
              </a:r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3 (5.9)</a:t>
              </a:r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3 (5.9)</a:t>
              </a:r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2 (4.0)</a:t>
              </a:r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1 (2.0)</a:t>
              </a:r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1 (2.0)</a:t>
              </a:r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1 (2.0)</a:t>
              </a:r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51" name="Text Box 27"/>
            <p:cNvSpPr/>
            <p:nvPr/>
          </p:nvSpPr>
          <p:spPr>
            <a:xfrm>
              <a:off x="3429000" y="216000"/>
              <a:ext cx="3900600" cy="825480"/>
            </a:xfrm>
            <a:prstGeom prst="rect">
              <a:avLst/>
            </a:prstGeom>
            <a:noFill/>
            <a:ln w="0">
              <a:noFill/>
            </a:ln>
            <a:effectLst>
              <a:outerShdw dist="17819" dir="2700000" blurRad="0" rotWithShape="0">
                <a:srgbClr val="00003d">
                  <a:alpha val="7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Perioperative complications</a:t>
              </a:r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52" name="Line 28"/>
            <p:cNvSpPr/>
            <p:nvPr/>
          </p:nvSpPr>
          <p:spPr>
            <a:xfrm>
              <a:off x="0" y="6130800"/>
              <a:ext cx="1028700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53" name="Line 33"/>
            <p:cNvSpPr/>
            <p:nvPr/>
          </p:nvSpPr>
          <p:spPr>
            <a:xfrm>
              <a:off x="-30240" y="779400"/>
              <a:ext cx="1028700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54" name="Line 34"/>
            <p:cNvSpPr/>
            <p:nvPr/>
          </p:nvSpPr>
          <p:spPr>
            <a:xfrm>
              <a:off x="12600" y="1952640"/>
              <a:ext cx="1028700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55" name="Line 40"/>
            <p:cNvSpPr/>
            <p:nvPr/>
          </p:nvSpPr>
          <p:spPr>
            <a:xfrm>
              <a:off x="5543640" y="1392120"/>
              <a:ext cx="471312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56" name="Rectangle 48"/>
            <p:cNvSpPr/>
            <p:nvPr/>
          </p:nvSpPr>
          <p:spPr>
            <a:xfrm>
              <a:off x="7194600" y="853920"/>
              <a:ext cx="163008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Diversion</a:t>
              </a:r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57" name="Rectangle 49"/>
            <p:cNvSpPr/>
            <p:nvPr/>
          </p:nvSpPr>
          <p:spPr>
            <a:xfrm>
              <a:off x="6132240" y="1401840"/>
              <a:ext cx="160704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IC (n = 25)</a:t>
              </a:r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58" name="Rectangle 55"/>
            <p:cNvSpPr/>
            <p:nvPr/>
          </p:nvSpPr>
          <p:spPr>
            <a:xfrm>
              <a:off x="36000" y="231840"/>
              <a:ext cx="146232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Table S3.</a:t>
              </a:r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59" name="Text Box 56"/>
            <p:cNvSpPr/>
            <p:nvPr/>
          </p:nvSpPr>
          <p:spPr>
            <a:xfrm>
              <a:off x="6170400" y="2170080"/>
              <a:ext cx="1695240" cy="3751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11 (44.0)</a:t>
              </a:r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3 (12.0)</a:t>
              </a:r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2 (8.0)</a:t>
              </a:r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3 (12.0)</a:t>
              </a:r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2 (8.0)</a:t>
              </a:r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0 (0)</a:t>
              </a:r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1 (4.0)</a:t>
              </a:r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0 (0)</a:t>
              </a:r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0 (0)</a:t>
              </a:r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60" name="Rectangle 49"/>
            <p:cNvSpPr/>
            <p:nvPr/>
          </p:nvSpPr>
          <p:spPr>
            <a:xfrm>
              <a:off x="8038440" y="1401840"/>
              <a:ext cx="174132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NB (n = 26)</a:t>
              </a:r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61" name="Text Box 56"/>
            <p:cNvSpPr/>
            <p:nvPr/>
          </p:nvSpPr>
          <p:spPr>
            <a:xfrm>
              <a:off x="8086680" y="2170080"/>
              <a:ext cx="1971720" cy="3751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8 (30.8)</a:t>
              </a:r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1 (3.8)</a:t>
              </a:r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2 (7.7)</a:t>
              </a:r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0 (0)</a:t>
              </a:r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1 (3.8)</a:t>
              </a:r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2 (7.7)</a:t>
              </a:r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0 (0)</a:t>
              </a:r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1 (3.8)</a:t>
              </a:r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1 (3.8)</a:t>
              </a:r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</p:grpSp>
      <p:sp>
        <p:nvSpPr>
          <p:cNvPr id="62" name="Rectangle 46"/>
          <p:cNvSpPr/>
          <p:nvPr/>
        </p:nvSpPr>
        <p:spPr>
          <a:xfrm>
            <a:off x="4114800" y="979560"/>
            <a:ext cx="1371600" cy="825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Total</a:t>
            </a:r>
            <a:endParaRPr b="1" lang="en-US" sz="2400" spc="-1" strike="noStrike">
              <a:solidFill>
                <a:srgbClr val="ffffff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(n = 51)</a:t>
            </a:r>
            <a:endParaRPr b="1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556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0-05-10T06:54:23Z</dcterms:created>
  <dc:creator>pal</dc:creator>
  <dc:description/>
  <dc:language>en-US</dc:language>
  <cp:lastModifiedBy>NOZOMI HAYAKAWA</cp:lastModifiedBy>
  <cp:lastPrinted>2015-01-22T06:15:28Z</cp:lastPrinted>
  <dcterms:modified xsi:type="dcterms:W3CDTF">2015-08-05T00:20:21Z</dcterms:modified>
  <cp:revision>937</cp:revision>
  <dc:subject/>
  <dc:title>1501043</dc:title>
</cp:coreProperties>
</file>